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  <p:sldId id="26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</p:sldIdLst>
  <p:sldSz cx="9906000" cy="6858000" type="A4"/>
  <p:notesSz cx="9926638" cy="67976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21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114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1"/>
            </a:lvl1pPr>
            <a:lvl2pPr marL="457181" indent="0" algn="ctr">
              <a:buNone/>
              <a:defRPr sz="2000"/>
            </a:lvl2pPr>
            <a:lvl3pPr marL="914362" indent="0" algn="ctr">
              <a:buNone/>
              <a:defRPr sz="1800"/>
            </a:lvl3pPr>
            <a:lvl4pPr marL="1371543" indent="0" algn="ctr">
              <a:buNone/>
              <a:defRPr sz="1600"/>
            </a:lvl4pPr>
            <a:lvl5pPr marL="1828723" indent="0" algn="ctr">
              <a:buNone/>
              <a:defRPr sz="1600"/>
            </a:lvl5pPr>
            <a:lvl6pPr marL="2285905" indent="0" algn="ctr">
              <a:buNone/>
              <a:defRPr sz="1600"/>
            </a:lvl6pPr>
            <a:lvl7pPr marL="2743085" indent="0" algn="ctr">
              <a:buNone/>
              <a:defRPr sz="1600"/>
            </a:lvl7pPr>
            <a:lvl8pPr marL="3200266" indent="0" algn="ctr">
              <a:buNone/>
              <a:defRPr sz="1600"/>
            </a:lvl8pPr>
            <a:lvl9pPr marL="3657446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70E65-35EF-468B-BF74-A24B36EF7E9A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2AB63-B1B1-410D-8FA0-D593EFC35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46227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70E65-35EF-468B-BF74-A24B36EF7E9A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2AB63-B1B1-410D-8FA0-D593EFC35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17699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70E65-35EF-468B-BF74-A24B36EF7E9A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2AB63-B1B1-410D-8FA0-D593EFC35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6676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70E65-35EF-468B-BF74-A24B36EF7E9A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2AB63-B1B1-410D-8FA0-D593EFC35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70959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81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81" y="4589466"/>
            <a:ext cx="8543925" cy="1500187"/>
          </a:xfrm>
        </p:spPr>
        <p:txBody>
          <a:bodyPr/>
          <a:lstStyle>
            <a:lvl1pPr marL="0" indent="0">
              <a:buNone/>
              <a:defRPr sz="2401">
                <a:solidFill>
                  <a:schemeClr val="tx1"/>
                </a:solidFill>
              </a:defRPr>
            </a:lvl1pPr>
            <a:lvl2pPr marL="45718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62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0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08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2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4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70E65-35EF-468B-BF74-A24B36EF7E9A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2AB63-B1B1-410D-8FA0-D593EFC35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1209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70E65-35EF-468B-BF74-A24B36EF7E9A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2AB63-B1B1-410D-8FA0-D593EFC35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47930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30" y="1681164"/>
            <a:ext cx="4190702" cy="823912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181" indent="0">
              <a:buNone/>
              <a:defRPr sz="2000" b="1"/>
            </a:lvl2pPr>
            <a:lvl3pPr marL="914362" indent="0">
              <a:buNone/>
              <a:defRPr sz="1800" b="1"/>
            </a:lvl3pPr>
            <a:lvl4pPr marL="1371543" indent="0">
              <a:buNone/>
              <a:defRPr sz="1600" b="1"/>
            </a:lvl4pPr>
            <a:lvl5pPr marL="1828723" indent="0">
              <a:buNone/>
              <a:defRPr sz="1600" b="1"/>
            </a:lvl5pPr>
            <a:lvl6pPr marL="2285905" indent="0">
              <a:buNone/>
              <a:defRPr sz="1600" b="1"/>
            </a:lvl6pPr>
            <a:lvl7pPr marL="2743085" indent="0">
              <a:buNone/>
              <a:defRPr sz="1600" b="1"/>
            </a:lvl7pPr>
            <a:lvl8pPr marL="3200266" indent="0">
              <a:buNone/>
              <a:defRPr sz="1600" b="1"/>
            </a:lvl8pPr>
            <a:lvl9pPr marL="3657446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30" y="2505076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4" y="1681164"/>
            <a:ext cx="4211340" cy="823912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181" indent="0">
              <a:buNone/>
              <a:defRPr sz="2000" b="1"/>
            </a:lvl2pPr>
            <a:lvl3pPr marL="914362" indent="0">
              <a:buNone/>
              <a:defRPr sz="1800" b="1"/>
            </a:lvl3pPr>
            <a:lvl4pPr marL="1371543" indent="0">
              <a:buNone/>
              <a:defRPr sz="1600" b="1"/>
            </a:lvl4pPr>
            <a:lvl5pPr marL="1828723" indent="0">
              <a:buNone/>
              <a:defRPr sz="1600" b="1"/>
            </a:lvl5pPr>
            <a:lvl6pPr marL="2285905" indent="0">
              <a:buNone/>
              <a:defRPr sz="1600" b="1"/>
            </a:lvl6pPr>
            <a:lvl7pPr marL="2743085" indent="0">
              <a:buNone/>
              <a:defRPr sz="1600" b="1"/>
            </a:lvl7pPr>
            <a:lvl8pPr marL="3200266" indent="0">
              <a:buNone/>
              <a:defRPr sz="1600" b="1"/>
            </a:lvl8pPr>
            <a:lvl9pPr marL="3657446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4" y="2505076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70E65-35EF-468B-BF74-A24B36EF7E9A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2AB63-B1B1-410D-8FA0-D593EFC35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1239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70E65-35EF-468B-BF74-A24B36EF7E9A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2AB63-B1B1-410D-8FA0-D593EFC35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66926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70E65-35EF-468B-BF74-A24B36EF7E9A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2AB63-B1B1-410D-8FA0-D593EFC35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7152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31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1" y="987428"/>
            <a:ext cx="5014913" cy="4873625"/>
          </a:xfrm>
        </p:spPr>
        <p:txBody>
          <a:bodyPr/>
          <a:lstStyle>
            <a:lvl1pPr>
              <a:defRPr sz="3199"/>
            </a:lvl1pPr>
            <a:lvl2pPr>
              <a:defRPr sz="2799"/>
            </a:lvl2pPr>
            <a:lvl3pPr>
              <a:defRPr sz="2401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1" indent="0">
              <a:buNone/>
              <a:defRPr sz="1400"/>
            </a:lvl2pPr>
            <a:lvl3pPr marL="914362" indent="0">
              <a:buNone/>
              <a:defRPr sz="1200"/>
            </a:lvl3pPr>
            <a:lvl4pPr marL="1371543" indent="0">
              <a:buNone/>
              <a:defRPr sz="1000"/>
            </a:lvl4pPr>
            <a:lvl5pPr marL="1828723" indent="0">
              <a:buNone/>
              <a:defRPr sz="1000"/>
            </a:lvl5pPr>
            <a:lvl6pPr marL="2285905" indent="0">
              <a:buNone/>
              <a:defRPr sz="1000"/>
            </a:lvl6pPr>
            <a:lvl7pPr marL="2743085" indent="0">
              <a:buNone/>
              <a:defRPr sz="1000"/>
            </a:lvl7pPr>
            <a:lvl8pPr marL="3200266" indent="0">
              <a:buNone/>
              <a:defRPr sz="1000"/>
            </a:lvl8pPr>
            <a:lvl9pPr marL="3657446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70E65-35EF-468B-BF74-A24B36EF7E9A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2AB63-B1B1-410D-8FA0-D593EFC35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22382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31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1" y="987428"/>
            <a:ext cx="5014913" cy="4873625"/>
          </a:xfrm>
        </p:spPr>
        <p:txBody>
          <a:bodyPr anchor="t"/>
          <a:lstStyle>
            <a:lvl1pPr marL="0" indent="0">
              <a:buNone/>
              <a:defRPr sz="3199"/>
            </a:lvl1pPr>
            <a:lvl2pPr marL="457181" indent="0">
              <a:buNone/>
              <a:defRPr sz="2799"/>
            </a:lvl2pPr>
            <a:lvl3pPr marL="914362" indent="0">
              <a:buNone/>
              <a:defRPr sz="2401"/>
            </a:lvl3pPr>
            <a:lvl4pPr marL="1371543" indent="0">
              <a:buNone/>
              <a:defRPr sz="2000"/>
            </a:lvl4pPr>
            <a:lvl5pPr marL="1828723" indent="0">
              <a:buNone/>
              <a:defRPr sz="2000"/>
            </a:lvl5pPr>
            <a:lvl6pPr marL="2285905" indent="0">
              <a:buNone/>
              <a:defRPr sz="2000"/>
            </a:lvl6pPr>
            <a:lvl7pPr marL="2743085" indent="0">
              <a:buNone/>
              <a:defRPr sz="2000"/>
            </a:lvl7pPr>
            <a:lvl8pPr marL="3200266" indent="0">
              <a:buNone/>
              <a:defRPr sz="2000"/>
            </a:lvl8pPr>
            <a:lvl9pPr marL="3657446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1" indent="0">
              <a:buNone/>
              <a:defRPr sz="1400"/>
            </a:lvl2pPr>
            <a:lvl3pPr marL="914362" indent="0">
              <a:buNone/>
              <a:defRPr sz="1200"/>
            </a:lvl3pPr>
            <a:lvl4pPr marL="1371543" indent="0">
              <a:buNone/>
              <a:defRPr sz="1000"/>
            </a:lvl4pPr>
            <a:lvl5pPr marL="1828723" indent="0">
              <a:buNone/>
              <a:defRPr sz="1000"/>
            </a:lvl5pPr>
            <a:lvl6pPr marL="2285905" indent="0">
              <a:buNone/>
              <a:defRPr sz="1000"/>
            </a:lvl6pPr>
            <a:lvl7pPr marL="2743085" indent="0">
              <a:buNone/>
              <a:defRPr sz="1000"/>
            </a:lvl7pPr>
            <a:lvl8pPr marL="3200266" indent="0">
              <a:buNone/>
              <a:defRPr sz="1000"/>
            </a:lvl8pPr>
            <a:lvl9pPr marL="3657446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70E65-35EF-468B-BF74-A24B36EF7E9A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2AB63-B1B1-410D-8FA0-D593EFC35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61088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9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9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3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C70E65-35EF-468B-BF74-A24B36EF7E9A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4" y="6356353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3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82AB63-B1B1-410D-8FA0-D593EFC35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58515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362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1" indent="-228591" algn="l" defTabSz="914362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799" kern="1200">
          <a:solidFill>
            <a:schemeClr val="tx1"/>
          </a:solidFill>
          <a:latin typeface="+mn-lt"/>
          <a:ea typeface="+mn-ea"/>
          <a:cs typeface="+mn-cs"/>
        </a:defRPr>
      </a:lvl1pPr>
      <a:lvl2pPr marL="685771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1" kern="1200">
          <a:solidFill>
            <a:schemeClr val="tx1"/>
          </a:solidFill>
          <a:latin typeface="+mn-lt"/>
          <a:ea typeface="+mn-ea"/>
          <a:cs typeface="+mn-cs"/>
        </a:defRPr>
      </a:lvl2pPr>
      <a:lvl3pPr marL="1142952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32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14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95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75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57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37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1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62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43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23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05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85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66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46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4C3FD0EF-1D51-462C-83F5-652AFB061A67}"/>
              </a:ext>
            </a:extLst>
          </p:cNvPr>
          <p:cNvSpPr/>
          <p:nvPr/>
        </p:nvSpPr>
        <p:spPr>
          <a:xfrm>
            <a:off x="854015" y="743228"/>
            <a:ext cx="8678173" cy="42217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coding the biological information contained in two ancient Slavonic parchment codices: an added historical value</a:t>
            </a:r>
            <a:endParaRPr lang="en-DE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de-AT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uadalupe Piñar</a:t>
            </a:r>
            <a:r>
              <a:rPr lang="de-AT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*</a:t>
            </a:r>
            <a:r>
              <a:rPr lang="de-AT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Hakim Tafer</a:t>
            </a:r>
            <a:r>
              <a:rPr lang="de-AT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de-AT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lang="de-AT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AT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nfred Schreiner</a:t>
            </a:r>
            <a:r>
              <a:rPr lang="de-AT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de-AT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Heinz Miklas</a:t>
            </a:r>
            <a:r>
              <a:rPr lang="de-AT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de-AT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Katja Sterflinger</a:t>
            </a:r>
            <a:r>
              <a:rPr lang="de-AT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</a:p>
          <a:p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stitute of Microbiology and Microbial Biotechnology, Department of Biotechnology, University of Natural Resources and Life Sciences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thgass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1, A-1190 Vienna, Austria</a:t>
            </a:r>
            <a:endParaRPr lang="en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stitute of Science and Technology in Art (ISTA), Academy of Fine Arts.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hillerplatz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, A-1010 Vienna, Austria</a:t>
            </a:r>
            <a:endParaRPr lang="en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partment of Slavonic Studies, University of Vienna.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italgasse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-4, Hof 3, A-1090 Vienna, Austria</a:t>
            </a:r>
            <a:endParaRPr lang="en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endParaRPr lang="de-AT" sz="1200" b="1" baseline="300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Corresponding author: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uadalupe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iñar</a:t>
            </a:r>
            <a:endParaRPr lang="en-DE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stitute of Microbiology and Microbial Biotechnology. Department of Biotechnology, University of Natural Resources and Life Sciences,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uthgass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11, A-1190 Vienna, Austria. </a:t>
            </a:r>
            <a:endParaRPr lang="en-DE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-mail: guadalupe.pinar@boku.ac.at / Tel: +43 1 47654 79862/ Fax: +43 1 47654 79009</a:t>
            </a:r>
            <a:endParaRPr lang="en-DE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unning Title: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iocodicology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pplied to ancient Slavonic codices</a:t>
            </a:r>
            <a:endParaRPr lang="en-DE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611666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F4F0029F-73FE-45B8-A1BF-322D60FF969F}"/>
              </a:ext>
            </a:extLst>
          </p:cNvPr>
          <p:cNvSpPr/>
          <p:nvPr/>
        </p:nvSpPr>
        <p:spPr>
          <a:xfrm>
            <a:off x="1304387" y="1052422"/>
            <a:ext cx="7297228" cy="4509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</a:t>
            </a:r>
            <a:r>
              <a:rPr lang="en-US" sz="12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utadapt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mmand line arguments for the four datasets presented in this study were:</a:t>
            </a:r>
            <a:endParaRPr lang="en-DE" sz="1200" b="1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886" indent="-342886">
              <a:lnSpc>
                <a:spcPct val="200000"/>
              </a:lnSpc>
              <a:spcAft>
                <a:spcPts val="800"/>
              </a:spcAft>
              <a:buFont typeface="+mj-lt"/>
              <a:buAutoNum type="arabicPeriod"/>
              <a:tabLst>
                <a:tab pos="457181" algn="l"/>
              </a:tabLst>
            </a:pP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utadapt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-m 20 -u 5 -a AGATCGGAAGAGCACACGTCTGAACTCCAGTCACATTCAGAAATCTCGTAT -j 8 -O 10 -e 0.2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ads_ATTCAGAA.fastq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&gt;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ads_ATTCAGAA.trimmed.fastq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endParaRPr lang="en-DE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886" indent="-342886">
              <a:lnSpc>
                <a:spcPct val="200000"/>
              </a:lnSpc>
              <a:spcAft>
                <a:spcPts val="800"/>
              </a:spcAft>
              <a:buFont typeface="+mj-lt"/>
              <a:buAutoNum type="arabicPeriod"/>
              <a:tabLst>
                <a:tab pos="457181" algn="l"/>
              </a:tabLst>
            </a:pP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utadapt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-m 20 -u 5 -a AGATCGGAAGAGCACACGTCTGAACTCCAGTCACGAGATTCCATCTCGTAT -j 8 -O 10 -e 0.2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ads_GAGATTCC.fastq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&gt;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ads_GAGATTCC.trimmed.fastq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                                                                                                        </a:t>
            </a:r>
            <a:endParaRPr lang="en-DE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886" indent="-342886">
              <a:lnSpc>
                <a:spcPct val="200000"/>
              </a:lnSpc>
              <a:spcAft>
                <a:spcPts val="800"/>
              </a:spcAft>
              <a:buFont typeface="+mj-lt"/>
              <a:buAutoNum type="arabicPeriod"/>
              <a:tabLst>
                <a:tab pos="457181" algn="l"/>
              </a:tabLst>
            </a:pP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utadapt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-j 8 -m 20 -u 5 -l 83 -a  AGATCGGAAGAGCACACGTCTGAACTCCAGTCACATTCAGAAATCTCGTAT -O 10 -e 0.2 --max-n=0 vaticana_Slav3P.fastq &gt; vaticana_Slav3P.trimmed.fastq                                                                                                      </a:t>
            </a:r>
            <a:endParaRPr lang="en-DE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886" indent="-342886">
              <a:lnSpc>
                <a:spcPct val="200000"/>
              </a:lnSpc>
              <a:spcAft>
                <a:spcPts val="800"/>
              </a:spcAft>
              <a:buFont typeface="+mj-lt"/>
              <a:buAutoNum type="arabicPeriod"/>
              <a:tabLst>
                <a:tab pos="457181" algn="l"/>
              </a:tabLs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utadapt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-j 8 -m 20 -u 8 -l 75 -a  AGATCGGAAGAGCACACGTCTGAACTCCAGTCACCGGCTATGATCTCGTAT -O 10 -e 0.2 --max-n=0 vaticana_Slav3Rb.fastq &gt; vaticana_Slav3Rb.trimmed.fastq    </a:t>
            </a:r>
            <a:endParaRPr lang="en-DE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7731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5F637863-529F-4246-B086-22D846165FA3}"/>
              </a:ext>
            </a:extLst>
          </p:cNvPr>
          <p:cNvSpPr/>
          <p:nvPr/>
        </p:nvSpPr>
        <p:spPr>
          <a:xfrm>
            <a:off x="517585" y="606835"/>
            <a:ext cx="8870830" cy="58694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le Legends:</a:t>
            </a:r>
            <a:endParaRPr lang="de-AT" sz="12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.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Krona chart displaying the relative abundance of Bacteria identified in the </a:t>
            </a:r>
            <a:r>
              <a:rPr 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iturgiarium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inaiticum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t the genus level. Cutoff 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˃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% of the total bacterial community. A) Sample 5 (Cod. Sin. Slav. 5N, Folio 3) and B) sample 6 (Cod. Sin. Slav. 5N, Fragment EDV 68).</a:t>
            </a:r>
            <a:endParaRPr lang="en-DE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.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Krona chart displaying the relative abundance of Bacteria identified in the Codex </a:t>
            </a:r>
            <a:r>
              <a:rPr 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ssemanianu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t the genus level. Cutoff ˃1% of the total bacterial community. A) Sample P (Vat-Slav-3P) and B) sample R (Vat-Slav-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b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</a:t>
            </a:r>
            <a:endParaRPr lang="en-DE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.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Krona chart displaying the relative abundance of Archaea identified in the Codex </a:t>
            </a:r>
            <a:r>
              <a:rPr 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ssemanianus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t the genus level. Cutoff ˃1% of the total archaeal community. A) Sample P (Vat-Slav-3P) and B) sample R (Vat-Slav-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b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</a:t>
            </a:r>
            <a:endParaRPr lang="en-DE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4.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Krona chart displaying the relative abundance of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ukaryota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dentified in the </a:t>
            </a:r>
            <a:r>
              <a:rPr 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iturgiarium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inaiticum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t the family/genus level. Cutoff ˃1% of the total eukaryotic community. A) Sample 5 (Cod. Sin. Slav. 5N, Folio 3) and B) sample 6 (Cod. Sin. Slav. 5N, Fragment EDV 68).</a:t>
            </a:r>
            <a:endParaRPr lang="en-DE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5.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Krona chart displaying the relative abundance of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ukaryota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dentified in the Codex </a:t>
            </a:r>
            <a:r>
              <a:rPr 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ssemanianus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t the family/genus level. Cutoff ˃1% of the total eukaryotic community. A) Sample P (Vat-Slav-3P) and B) sample R (Vat-Slav-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b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</a:t>
            </a:r>
            <a:endParaRPr lang="en-DE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6.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Krona chart displaying the relative abundance of viruses identified in the </a:t>
            </a:r>
            <a:r>
              <a:rPr 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iturgiarium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inaiticum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utoff ˃1% of the total viruses. A) Sample 5 (Cod. Sin. Slav. 5N, Folio 3) and B) sample 6 (Cod. Sin. Slav. 5N, Fragment EDV 68).</a:t>
            </a:r>
            <a:endParaRPr lang="en-DE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7.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Krona chart displaying the relative abundance of viruses identified in the Codex </a:t>
            </a:r>
            <a:r>
              <a:rPr 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ssemanianus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utoff ˃1% of the total viruses. A) Sample P (Vat-Slav-3P) and B) sample R (Vat-Slav-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b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</a:t>
            </a:r>
            <a:endParaRPr lang="en-DE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ext.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he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utadapt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mmand line arguments for the four datasets presented in this study.</a:t>
            </a:r>
            <a:endParaRPr lang="en-DE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90932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579" name="Content Placeholder 2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70249" y="2057879"/>
            <a:ext cx="4243079" cy="4013896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58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6421" y="2057878"/>
            <a:ext cx="4440432" cy="3856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4583" name="TextBox 3"/>
          <p:cNvSpPr txBox="1">
            <a:spLocks noChangeArrowheads="1"/>
          </p:cNvSpPr>
          <p:nvPr/>
        </p:nvSpPr>
        <p:spPr bwMode="auto">
          <a:xfrm>
            <a:off x="2386654" y="1051436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1pPr>
            <a:lvl2pPr marL="742950" indent="-28575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2pPr>
            <a:lvl3pPr marL="11430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3pPr>
            <a:lvl4pPr marL="16002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4pPr>
            <a:lvl5pPr marL="20574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9pPr>
          </a:lstStyle>
          <a:p>
            <a:r>
              <a:rPr lang="de-AT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584" name="TextBox 8"/>
          <p:cNvSpPr txBox="1">
            <a:spLocks noChangeArrowheads="1"/>
          </p:cNvSpPr>
          <p:nvPr/>
        </p:nvSpPr>
        <p:spPr bwMode="auto">
          <a:xfrm>
            <a:off x="7006932" y="1057800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1pPr>
            <a:lvl2pPr marL="742950" indent="-28575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2pPr>
            <a:lvl3pPr marL="11430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3pPr>
            <a:lvl4pPr marL="16002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4pPr>
            <a:lvl5pPr marL="20574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9pPr>
          </a:lstStyle>
          <a:p>
            <a:r>
              <a:rPr lang="de-AT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C657A54-4236-4547-B16A-5C9ABA0A6558}"/>
              </a:ext>
            </a:extLst>
          </p:cNvPr>
          <p:cNvSpPr txBox="1"/>
          <p:nvPr/>
        </p:nvSpPr>
        <p:spPr>
          <a:xfrm>
            <a:off x="428489" y="331049"/>
            <a:ext cx="2088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689582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675" name="Content Placeholder 1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6548" y="1615428"/>
            <a:ext cx="4675982" cy="4521599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8678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41867" y="2274332"/>
            <a:ext cx="4246262" cy="38276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8679" name="TextBox 5"/>
          <p:cNvSpPr txBox="1">
            <a:spLocks noChangeArrowheads="1"/>
          </p:cNvSpPr>
          <p:nvPr/>
        </p:nvSpPr>
        <p:spPr bwMode="auto">
          <a:xfrm>
            <a:off x="2800956" y="1138661"/>
            <a:ext cx="41521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1pPr>
            <a:lvl2pPr marL="742950" indent="-28575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2pPr>
            <a:lvl3pPr marL="11430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3pPr>
            <a:lvl4pPr marL="16002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4pPr>
            <a:lvl5pPr marL="20574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9pPr>
          </a:lstStyle>
          <a:p>
            <a:r>
              <a:rPr lang="de-AT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680" name="TextBox 10"/>
          <p:cNvSpPr txBox="1">
            <a:spLocks noChangeArrowheads="1"/>
          </p:cNvSpPr>
          <p:nvPr/>
        </p:nvSpPr>
        <p:spPr bwMode="auto">
          <a:xfrm>
            <a:off x="6951427" y="1138661"/>
            <a:ext cx="160450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1pPr>
            <a:lvl2pPr marL="742950" indent="-28575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2pPr>
            <a:lvl3pPr marL="11430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3pPr>
            <a:lvl4pPr marL="16002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4pPr>
            <a:lvl5pPr marL="20574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9pPr>
          </a:lstStyle>
          <a:p>
            <a:r>
              <a:rPr lang="de-AT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Ellipse 1"/>
          <p:cNvSpPr>
            <a:spLocks noChangeArrowheads="1"/>
          </p:cNvSpPr>
          <p:nvPr/>
        </p:nvSpPr>
        <p:spPr bwMode="auto">
          <a:xfrm rot="-946362">
            <a:off x="358983" y="4358868"/>
            <a:ext cx="1464228" cy="433694"/>
          </a:xfrm>
          <a:prstGeom prst="ellipse">
            <a:avLst/>
          </a:prstGeom>
          <a:noFill/>
          <a:ln w="9525" algn="ctr">
            <a:solidFill>
              <a:srgbClr val="FF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anchor="ctr">
            <a:spAutoFit/>
          </a:bodyPr>
          <a:lstStyle>
            <a:lvl1pPr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1pPr>
            <a:lvl2pPr marL="742950" indent="-28575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2pPr>
            <a:lvl3pPr marL="11430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3pPr>
            <a:lvl4pPr marL="16002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4pPr>
            <a:lvl5pPr marL="20574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endParaRPr lang="de-DE" altLang="de-DE" sz="1404"/>
          </a:p>
        </p:txBody>
      </p:sp>
      <p:sp>
        <p:nvSpPr>
          <p:cNvPr id="11" name="Ellipse 10"/>
          <p:cNvSpPr>
            <a:spLocks noChangeArrowheads="1"/>
          </p:cNvSpPr>
          <p:nvPr/>
        </p:nvSpPr>
        <p:spPr bwMode="auto">
          <a:xfrm rot="3433859">
            <a:off x="7390464" y="5305842"/>
            <a:ext cx="1464228" cy="433694"/>
          </a:xfrm>
          <a:prstGeom prst="ellipse">
            <a:avLst/>
          </a:prstGeom>
          <a:noFill/>
          <a:ln w="9525" algn="ctr">
            <a:solidFill>
              <a:srgbClr val="FF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anchor="ctr">
            <a:spAutoFit/>
          </a:bodyPr>
          <a:lstStyle>
            <a:lvl1pPr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1pPr>
            <a:lvl2pPr marL="742950" indent="-28575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2pPr>
            <a:lvl3pPr marL="11430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3pPr>
            <a:lvl4pPr marL="16002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4pPr>
            <a:lvl5pPr marL="20574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endParaRPr lang="de-DE" altLang="de-DE" sz="1404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1E02F680-3BB9-48EC-97B1-77D1F6E432A7}"/>
              </a:ext>
            </a:extLst>
          </p:cNvPr>
          <p:cNvSpPr/>
          <p:nvPr/>
        </p:nvSpPr>
        <p:spPr>
          <a:xfrm>
            <a:off x="396465" y="357793"/>
            <a:ext cx="20889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638335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 animBg="1"/>
      <p:bldP spid="11" grpId="0" animBg="1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83" name="TextBox 3"/>
          <p:cNvSpPr txBox="1">
            <a:spLocks noChangeArrowheads="1"/>
          </p:cNvSpPr>
          <p:nvPr/>
        </p:nvSpPr>
        <p:spPr bwMode="auto">
          <a:xfrm>
            <a:off x="2599479" y="1044015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1pPr>
            <a:lvl2pPr marL="742950" indent="-28575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2pPr>
            <a:lvl3pPr marL="11430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3pPr>
            <a:lvl4pPr marL="16002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4pPr>
            <a:lvl5pPr marL="20574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9pPr>
          </a:lstStyle>
          <a:p>
            <a:r>
              <a:rPr lang="de-AT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584" name="TextBox 8"/>
          <p:cNvSpPr txBox="1">
            <a:spLocks noChangeArrowheads="1"/>
          </p:cNvSpPr>
          <p:nvPr/>
        </p:nvSpPr>
        <p:spPr bwMode="auto">
          <a:xfrm>
            <a:off x="7075810" y="1044015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1pPr>
            <a:lvl2pPr marL="742950" indent="-28575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2pPr>
            <a:lvl3pPr marL="11430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3pPr>
            <a:lvl4pPr marL="16002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4pPr>
            <a:lvl5pPr marL="20574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9pPr>
          </a:lstStyle>
          <a:p>
            <a:r>
              <a:rPr lang="de-AT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97751" y="1787993"/>
            <a:ext cx="3317648" cy="4057644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46420" y="2442160"/>
            <a:ext cx="4229660" cy="3915210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21F47971-CDEF-41FD-B8F5-1A90657E4D0A}"/>
              </a:ext>
            </a:extLst>
          </p:cNvPr>
          <p:cNvSpPr/>
          <p:nvPr/>
        </p:nvSpPr>
        <p:spPr>
          <a:xfrm>
            <a:off x="384495" y="346741"/>
            <a:ext cx="20889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8441465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Picture 2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2715" y="1931276"/>
            <a:ext cx="5105630" cy="3970356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91713" y="1536301"/>
            <a:ext cx="3465130" cy="4262857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577662" y="106052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380889" y="106052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AA770E3A-AAF7-413A-AF8C-880FDDF5C8A8}"/>
              </a:ext>
            </a:extLst>
          </p:cNvPr>
          <p:cNvSpPr/>
          <p:nvPr/>
        </p:nvSpPr>
        <p:spPr>
          <a:xfrm>
            <a:off x="384495" y="346741"/>
            <a:ext cx="20889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623048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83" name="TextBox 3"/>
          <p:cNvSpPr txBox="1">
            <a:spLocks noChangeArrowheads="1"/>
          </p:cNvSpPr>
          <p:nvPr/>
        </p:nvSpPr>
        <p:spPr bwMode="auto">
          <a:xfrm>
            <a:off x="2946781" y="1039848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1pPr>
            <a:lvl2pPr marL="742950" indent="-28575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2pPr>
            <a:lvl3pPr marL="11430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3pPr>
            <a:lvl4pPr marL="16002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4pPr>
            <a:lvl5pPr marL="20574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9pPr>
          </a:lstStyle>
          <a:p>
            <a:r>
              <a:rPr lang="de-AT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584" name="TextBox 8"/>
          <p:cNvSpPr txBox="1">
            <a:spLocks noChangeArrowheads="1"/>
          </p:cNvSpPr>
          <p:nvPr/>
        </p:nvSpPr>
        <p:spPr bwMode="auto">
          <a:xfrm>
            <a:off x="7304417" y="1039848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1pPr>
            <a:lvl2pPr marL="742950" indent="-28575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2pPr>
            <a:lvl3pPr marL="11430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3pPr>
            <a:lvl4pPr marL="16002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4pPr>
            <a:lvl5pPr marL="20574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9pPr>
          </a:lstStyle>
          <a:p>
            <a:r>
              <a:rPr lang="de-AT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0185" y="1922597"/>
            <a:ext cx="5396312" cy="3534727"/>
          </a:xfrm>
          <a:prstGeom prst="rect">
            <a:avLst/>
          </a:prstGeom>
        </p:spPr>
      </p:pic>
      <p:grpSp>
        <p:nvGrpSpPr>
          <p:cNvPr id="21" name="Group 20"/>
          <p:cNvGrpSpPr/>
          <p:nvPr/>
        </p:nvGrpSpPr>
        <p:grpSpPr>
          <a:xfrm>
            <a:off x="5936128" y="2372706"/>
            <a:ext cx="3181305" cy="3492623"/>
            <a:chOff x="5936128" y="2372705"/>
            <a:chExt cx="3181305" cy="3492624"/>
          </a:xfrm>
        </p:grpSpPr>
        <p:sp>
          <p:nvSpPr>
            <p:cNvPr id="8" name="TextBox 7"/>
            <p:cNvSpPr txBox="1"/>
            <p:nvPr/>
          </p:nvSpPr>
          <p:spPr>
            <a:xfrm>
              <a:off x="7271279" y="5634497"/>
              <a:ext cx="89639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imeria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0.7%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936128" y="2372705"/>
              <a:ext cx="3181305" cy="3140444"/>
            </a:xfrm>
            <a:prstGeom prst="rect">
              <a:avLst/>
            </a:prstGeom>
          </p:spPr>
        </p:pic>
        <p:cxnSp>
          <p:nvCxnSpPr>
            <p:cNvPr id="10" name="Straight Connector 9"/>
            <p:cNvCxnSpPr/>
            <p:nvPr/>
          </p:nvCxnSpPr>
          <p:spPr>
            <a:xfrm flipH="1" flipV="1">
              <a:off x="7540331" y="5454865"/>
              <a:ext cx="1" cy="23893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" name="Group 19"/>
          <p:cNvGrpSpPr/>
          <p:nvPr/>
        </p:nvGrpSpPr>
        <p:grpSpPr>
          <a:xfrm>
            <a:off x="7244480" y="1488167"/>
            <a:ext cx="440794" cy="1255034"/>
            <a:chOff x="7246709" y="1662137"/>
            <a:chExt cx="440794" cy="1179242"/>
          </a:xfrm>
        </p:grpSpPr>
        <p:sp>
          <p:nvSpPr>
            <p:cNvPr id="19" name="Rounded Rectangle 18"/>
            <p:cNvSpPr/>
            <p:nvPr/>
          </p:nvSpPr>
          <p:spPr>
            <a:xfrm rot="21290335">
              <a:off x="7246709" y="1662137"/>
              <a:ext cx="440794" cy="1179242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TextBox 5"/>
            <p:cNvSpPr txBox="1"/>
            <p:nvPr/>
          </p:nvSpPr>
          <p:spPr>
            <a:xfrm rot="5134995">
              <a:off x="6924897" y="2059394"/>
              <a:ext cx="1096761" cy="3847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de-A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sp</a:t>
              </a:r>
              <a:r>
                <a:rPr lang="de-AT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rgillaceae</a:t>
              </a:r>
              <a:endParaRPr lang="de-AT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de-AT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Unclassified</a:t>
              </a:r>
              <a:r>
                <a:rPr lang="de-AT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 99%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" name="Rectangle 11">
            <a:extLst>
              <a:ext uri="{FF2B5EF4-FFF2-40B4-BE49-F238E27FC236}">
                <a16:creationId xmlns:a16="http://schemas.microsoft.com/office/drawing/2014/main" id="{89972143-AC65-4312-8903-458F34D3F652}"/>
              </a:ext>
            </a:extLst>
          </p:cNvPr>
          <p:cNvSpPr/>
          <p:nvPr/>
        </p:nvSpPr>
        <p:spPr>
          <a:xfrm>
            <a:off x="384495" y="346741"/>
            <a:ext cx="20889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7479563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83" name="TextBox 3"/>
          <p:cNvSpPr txBox="1">
            <a:spLocks noChangeArrowheads="1"/>
          </p:cNvSpPr>
          <p:nvPr/>
        </p:nvSpPr>
        <p:spPr bwMode="auto">
          <a:xfrm>
            <a:off x="2331471" y="996719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1pPr>
            <a:lvl2pPr marL="742950" indent="-28575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2pPr>
            <a:lvl3pPr marL="11430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3pPr>
            <a:lvl4pPr marL="16002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4pPr>
            <a:lvl5pPr marL="20574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9pPr>
          </a:lstStyle>
          <a:p>
            <a:r>
              <a:rPr lang="de-AT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584" name="TextBox 8"/>
          <p:cNvSpPr txBox="1">
            <a:spLocks noChangeArrowheads="1"/>
          </p:cNvSpPr>
          <p:nvPr/>
        </p:nvSpPr>
        <p:spPr bwMode="auto">
          <a:xfrm>
            <a:off x="7304417" y="996719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1pPr>
            <a:lvl2pPr marL="742950" indent="-28575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2pPr>
            <a:lvl3pPr marL="11430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3pPr>
            <a:lvl4pPr marL="16002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4pPr>
            <a:lvl5pPr marL="20574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9pPr>
          </a:lstStyle>
          <a:p>
            <a:r>
              <a:rPr lang="de-AT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" name="Group 15"/>
          <p:cNvGrpSpPr/>
          <p:nvPr/>
        </p:nvGrpSpPr>
        <p:grpSpPr>
          <a:xfrm>
            <a:off x="585818" y="1805146"/>
            <a:ext cx="4553202" cy="3845144"/>
            <a:chOff x="759236" y="2010098"/>
            <a:chExt cx="4553202" cy="3845144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02613" y="2010098"/>
              <a:ext cx="3490105" cy="3845144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4072996" y="3173761"/>
              <a:ext cx="1239442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de-A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Jaagsiekte</a:t>
              </a:r>
              <a:r>
                <a:rPr lang="de-A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A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heep</a:t>
              </a:r>
              <a:endParaRPr lang="de-A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de-A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etrovirus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759236" y="2888548"/>
              <a:ext cx="1314784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r"/>
              <a:r>
                <a:rPr lang="de-A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ropionibacterium</a:t>
              </a:r>
              <a:endParaRPr lang="de-A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de-A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hage P101A 61%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" name="Group 14"/>
          <p:cNvGrpSpPr/>
          <p:nvPr/>
        </p:nvGrpSpPr>
        <p:grpSpPr>
          <a:xfrm>
            <a:off x="5382916" y="1505609"/>
            <a:ext cx="4005452" cy="3361149"/>
            <a:chOff x="5226023" y="2010098"/>
            <a:chExt cx="4335763" cy="3618192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226023" y="2010098"/>
              <a:ext cx="4156788" cy="3523921"/>
            </a:xfrm>
            <a:prstGeom prst="rect">
              <a:avLst/>
            </a:prstGeom>
          </p:spPr>
        </p:pic>
        <p:sp>
          <p:nvSpPr>
            <p:cNvPr id="13" name="Rectangle 12"/>
            <p:cNvSpPr/>
            <p:nvPr/>
          </p:nvSpPr>
          <p:spPr>
            <a:xfrm rot="2589145">
              <a:off x="8954814" y="5194738"/>
              <a:ext cx="606972" cy="43355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4" name="Rectangle 13">
            <a:extLst>
              <a:ext uri="{FF2B5EF4-FFF2-40B4-BE49-F238E27FC236}">
                <a16:creationId xmlns:a16="http://schemas.microsoft.com/office/drawing/2014/main" id="{27A9FE19-CFD3-43B6-A9C2-1AB793B5A9AD}"/>
              </a:ext>
            </a:extLst>
          </p:cNvPr>
          <p:cNvSpPr/>
          <p:nvPr/>
        </p:nvSpPr>
        <p:spPr>
          <a:xfrm>
            <a:off x="384495" y="346741"/>
            <a:ext cx="20889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6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6940781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/>
          <p:cNvGrpSpPr/>
          <p:nvPr/>
        </p:nvGrpSpPr>
        <p:grpSpPr>
          <a:xfrm>
            <a:off x="426112" y="720343"/>
            <a:ext cx="5028680" cy="5699235"/>
            <a:chOff x="254741" y="764629"/>
            <a:chExt cx="5028680" cy="5699234"/>
          </a:xfrm>
        </p:grpSpPr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69769" y="764629"/>
              <a:ext cx="4213652" cy="5699234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254741" y="3414190"/>
              <a:ext cx="1314784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r"/>
              <a:r>
                <a:rPr lang="de-A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ropionibacterium</a:t>
              </a:r>
              <a:endParaRPr lang="de-A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de-A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hage P101A 49%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4583" name="TextBox 3"/>
          <p:cNvSpPr txBox="1">
            <a:spLocks noChangeArrowheads="1"/>
          </p:cNvSpPr>
          <p:nvPr/>
        </p:nvSpPr>
        <p:spPr bwMode="auto">
          <a:xfrm>
            <a:off x="2427842" y="945930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1pPr>
            <a:lvl2pPr marL="742950" indent="-28575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2pPr>
            <a:lvl3pPr marL="11430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3pPr>
            <a:lvl4pPr marL="16002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4pPr>
            <a:lvl5pPr marL="20574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9pPr>
          </a:lstStyle>
          <a:p>
            <a:r>
              <a:rPr lang="de-AT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Picture 2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69515" y="945931"/>
            <a:ext cx="2844117" cy="5552478"/>
          </a:xfrm>
          <a:prstGeom prst="rect">
            <a:avLst/>
          </a:prstGeom>
        </p:spPr>
      </p:pic>
      <p:sp>
        <p:nvSpPr>
          <p:cNvPr id="24584" name="TextBox 8"/>
          <p:cNvSpPr txBox="1">
            <a:spLocks noChangeArrowheads="1"/>
          </p:cNvSpPr>
          <p:nvPr/>
        </p:nvSpPr>
        <p:spPr bwMode="auto">
          <a:xfrm>
            <a:off x="7215883" y="945930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1pPr>
            <a:lvl2pPr marL="742950" indent="-28575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2pPr>
            <a:lvl3pPr marL="11430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3pPr>
            <a:lvl4pPr marL="16002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4pPr>
            <a:lvl5pPr marL="2057400" indent="-228600"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 Narrow" panose="020B0606020202030204" pitchFamily="34" charset="0"/>
              </a:defRPr>
            </a:lvl9pPr>
          </a:lstStyle>
          <a:p>
            <a:r>
              <a:rPr lang="de-AT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CAD99196-285F-49CB-844F-5035679269B1}"/>
              </a:ext>
            </a:extLst>
          </p:cNvPr>
          <p:cNvSpPr/>
          <p:nvPr/>
        </p:nvSpPr>
        <p:spPr>
          <a:xfrm>
            <a:off x="384495" y="346741"/>
            <a:ext cx="20889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7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890021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83</Words>
  <Application>Microsoft Office PowerPoint</Application>
  <PresentationFormat>A4 Paper (210x297 mm)</PresentationFormat>
  <Paragraphs>54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6" baseType="lpstr">
      <vt:lpstr>Arial</vt:lpstr>
      <vt:lpstr>Arial Narrow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BOK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AM</dc:creator>
  <cp:lastModifiedBy>iam</cp:lastModifiedBy>
  <cp:revision>10</cp:revision>
  <cp:lastPrinted>2019-09-24T12:47:37Z</cp:lastPrinted>
  <dcterms:created xsi:type="dcterms:W3CDTF">2019-09-24T12:42:01Z</dcterms:created>
  <dcterms:modified xsi:type="dcterms:W3CDTF">2020-01-16T14:45:33Z</dcterms:modified>
</cp:coreProperties>
</file>